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2225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4563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4309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0231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8766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5091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1765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4362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9519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3442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585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42FB3-239F-4CD4-BC26-BA5CC3D9A83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A9C8AB-000F-4961-9BCE-162D57CAD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4577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836836" y="2030912"/>
            <a:ext cx="29202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3835379" y="2141162"/>
            <a:ext cx="28584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3784343" y="1920853"/>
            <a:ext cx="3346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7674486">
            <a:off x="4148619" y="1737786"/>
            <a:ext cx="6035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UIT 0-20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 rot="17674486">
            <a:off x="4017519" y="1709069"/>
            <a:ext cx="6498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eLa-CD9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 rot="17674486">
            <a:off x="3947510" y="1778254"/>
            <a:ext cx="4947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V4-1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Gerade Verbindung mit Pfeil 9"/>
          <p:cNvCxnSpPr/>
          <p:nvPr/>
        </p:nvCxnSpPr>
        <p:spPr>
          <a:xfrm flipH="1">
            <a:off x="4436429" y="210428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 flipH="1">
            <a:off x="4436077" y="221447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feld 11"/>
          <p:cNvSpPr txBox="1"/>
          <p:nvPr/>
        </p:nvSpPr>
        <p:spPr>
          <a:xfrm>
            <a:off x="4519992" y="2115909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4510863" y="2008070"/>
            <a:ext cx="485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74" t="31963" r="48516" b="64343"/>
          <a:stretch/>
        </p:blipFill>
        <p:spPr>
          <a:xfrm>
            <a:off x="4070196" y="2077247"/>
            <a:ext cx="360000" cy="847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13" t="40349" r="37877" b="55218"/>
          <a:stretch/>
        </p:blipFill>
        <p:spPr>
          <a:xfrm>
            <a:off x="4070196" y="2169872"/>
            <a:ext cx="360000" cy="101647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9634741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932271" y="163692"/>
            <a:ext cx="29202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6770680" y="112140"/>
            <a:ext cx="28584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Gerade Verbindung mit Pfeil 7"/>
          <p:cNvCxnSpPr/>
          <p:nvPr/>
        </p:nvCxnSpPr>
        <p:spPr>
          <a:xfrm flipH="1">
            <a:off x="1531864" y="23706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 Verbindung mit Pfeil 8"/>
          <p:cNvCxnSpPr/>
          <p:nvPr/>
        </p:nvCxnSpPr>
        <p:spPr>
          <a:xfrm flipH="1">
            <a:off x="7371378" y="18545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feld 9"/>
          <p:cNvSpPr txBox="1"/>
          <p:nvPr/>
        </p:nvSpPr>
        <p:spPr>
          <a:xfrm>
            <a:off x="7455293" y="86887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1606298" y="140850"/>
            <a:ext cx="485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74" t="31963" r="48516" b="64343"/>
          <a:stretch/>
        </p:blipFill>
        <p:spPr>
          <a:xfrm>
            <a:off x="1165631" y="210027"/>
            <a:ext cx="360000" cy="847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13" t="40349" r="37877" b="55218"/>
          <a:stretch/>
        </p:blipFill>
        <p:spPr>
          <a:xfrm>
            <a:off x="7005497" y="140850"/>
            <a:ext cx="360000" cy="1016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601" b="22725"/>
          <a:stretch/>
        </p:blipFill>
        <p:spPr>
          <a:xfrm>
            <a:off x="430690" y="3296733"/>
            <a:ext cx="3480483" cy="3215047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10" t="13335" r="27130" b="22762"/>
          <a:stretch/>
        </p:blipFill>
        <p:spPr>
          <a:xfrm>
            <a:off x="530197" y="390944"/>
            <a:ext cx="2881513" cy="2658675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03" t="24184" r="34570" b="22995"/>
          <a:stretch/>
        </p:blipFill>
        <p:spPr>
          <a:xfrm>
            <a:off x="6040001" y="299787"/>
            <a:ext cx="2650992" cy="2197633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140" b="18919"/>
          <a:stretch/>
        </p:blipFill>
        <p:spPr>
          <a:xfrm>
            <a:off x="4909166" y="3296733"/>
            <a:ext cx="4063992" cy="3373385"/>
          </a:xfrm>
          <a:prstGeom prst="rect">
            <a:avLst/>
          </a:prstGeom>
        </p:spPr>
      </p:pic>
      <p:sp>
        <p:nvSpPr>
          <p:cNvPr id="18" name="Rechteck 17"/>
          <p:cNvSpPr/>
          <p:nvPr/>
        </p:nvSpPr>
        <p:spPr>
          <a:xfrm>
            <a:off x="2094019" y="3324841"/>
            <a:ext cx="3911679" cy="60016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endParaRPr lang="en-US" sz="1100" b="1" dirty="0" smtClean="0">
              <a:solidFill>
                <a:schemeClr val="bg1"/>
              </a:solidFill>
            </a:endParaRPr>
          </a:p>
          <a:p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</a:p>
          <a:p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1824639" y="42044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1824639" y="42918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1824639" y="43832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1824639" y="44839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1824639" y="47074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1824639" y="49198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1824639" y="52841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1824639" y="54679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1824639" y="57854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1824639" y="40828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2515124" y="401056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0" name="Rechteck 29"/>
          <p:cNvSpPr/>
          <p:nvPr/>
        </p:nvSpPr>
        <p:spPr>
          <a:xfrm>
            <a:off x="1544792" y="1149209"/>
            <a:ext cx="750860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" name="Rechteck 30"/>
          <p:cNvSpPr/>
          <p:nvPr/>
        </p:nvSpPr>
        <p:spPr>
          <a:xfrm>
            <a:off x="1824639" y="604637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5712007" y="3410398"/>
            <a:ext cx="3911679" cy="60016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endParaRPr lang="en-US" sz="1100" b="1" dirty="0" smtClean="0">
              <a:solidFill>
                <a:schemeClr val="bg1"/>
              </a:solidFill>
            </a:endParaRPr>
          </a:p>
          <a:p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</a:p>
          <a:p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240994" y="43660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240994" y="44535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240994" y="45448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240994" y="46455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240994" y="48691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240994" y="50815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240994" y="54457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5240994" y="562954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240994" y="59470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240994" y="42444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5931479" y="417219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4" name="Rechteck 43"/>
          <p:cNvSpPr/>
          <p:nvPr/>
        </p:nvSpPr>
        <p:spPr>
          <a:xfrm>
            <a:off x="7893566" y="974906"/>
            <a:ext cx="611843" cy="1765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5" name="Rechteck 44"/>
          <p:cNvSpPr/>
          <p:nvPr/>
        </p:nvSpPr>
        <p:spPr>
          <a:xfrm>
            <a:off x="5240994" y="62080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3249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5</Words>
  <Application>Microsoft Office PowerPoint</Application>
  <PresentationFormat>Bildschirmpräsentation (4:3)</PresentationFormat>
  <Paragraphs>42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2</cp:revision>
  <dcterms:created xsi:type="dcterms:W3CDTF">2024-08-28T10:28:44Z</dcterms:created>
  <dcterms:modified xsi:type="dcterms:W3CDTF">2024-08-28T10:35:18Z</dcterms:modified>
</cp:coreProperties>
</file>